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 showGuides="1">
      <p:cViewPr>
        <p:scale>
          <a:sx n="100" d="100"/>
          <a:sy n="100" d="100"/>
        </p:scale>
        <p:origin x="-2528" y="-640"/>
      </p:cViewPr>
      <p:guideLst>
        <p:guide orient="horz"/>
        <p:guide pos="431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F663AC0-28C1-364F-A983-8662EC45F8EB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0FE64BB-615F-4243-AAF5-A2B7505AA8A1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9853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2E821E3-B966-E14F-A853-DEAC434042A1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2EEBF19-6524-394A-B075-37CA51388E1A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5504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E4C612D-62A9-D243-B291-0DD5E03FA361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6B7080D-188E-3D4A-A9B6-92E003825CEE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7040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E1335E-23F8-4644-9ED6-AC897F223D7A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94DE186-5652-5649-A115-EEEE4259A036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2977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2C6204C-6C18-D74A-8486-C5C0FC75293B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C00F3BD-477D-9F40-9BD7-E886A2F1D408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9403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4BF0568-5E02-6C41-B4B9-C7A074D7803D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B3B1F8B-B4D2-2145-BCF5-5E99DBE463A6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8535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E8780FA-8077-6941-A9D6-6B643FBDE7AE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604087E-0A49-4244-9770-8FCF85395B94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6821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A938148-9A34-7B47-B9F8-B3B11078D221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48BAADC-6D44-854C-8686-53DA92F2BA9A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0236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A4C4BFE-9957-2F44-90D8-8C00B37E3B58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A0FBD08-B011-464B-A7E2-EC9AEA9B2398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1903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00BB60E-E40F-F945-97B3-5C8C344F1FF9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F7542C-CA60-DB4D-838B-663FFD0B41F0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6261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0E34D7C-8B65-AC48-B5D9-A6DD5302C7F5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FEBEAB7-1148-9045-8E13-0C42B2BEB379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2968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5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fld id="{6F581949-AF59-1044-BA20-79B84A59F5D4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5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5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fld id="{9B8411E1-6FA4-0144-8C59-E1369BAFF261}" type="slidenum">
              <a:rPr lang="de-DE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65" charset="-128"/>
          <a:cs typeface="ＭＳ Ｐゴシック" pitchFamily="-65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pitchFamily="-65" charset="-128"/>
          <a:cs typeface="ＭＳ Ｐゴシック" pitchFamily="-65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216496" y="4283968"/>
            <a:ext cx="28681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E</a:t>
            </a:r>
            <a:r>
              <a:rPr lang="de-DE" sz="1400" dirty="0" err="1" smtClean="0"/>
              <a:t>xclusion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dublette</a:t>
            </a:r>
            <a:r>
              <a:rPr lang="de-DE" sz="1400" dirty="0" smtClean="0"/>
              <a:t> </a:t>
            </a:r>
            <a:r>
              <a:rPr lang="de-DE" sz="1400" dirty="0" err="1" smtClean="0"/>
              <a:t>cells</a:t>
            </a:r>
            <a:endParaRPr lang="de-DE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4149080" y="4283968"/>
            <a:ext cx="27363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G</a:t>
            </a:r>
            <a:r>
              <a:rPr lang="de-DE" sz="1400" dirty="0" err="1" smtClean="0"/>
              <a:t>ating</a:t>
            </a:r>
            <a:r>
              <a:rPr lang="de-DE" sz="1400" dirty="0" smtClean="0"/>
              <a:t> on HEK293 </a:t>
            </a:r>
            <a:r>
              <a:rPr lang="de-DE" sz="1400" dirty="0" err="1" smtClean="0"/>
              <a:t>population</a:t>
            </a:r>
            <a:endParaRPr lang="de-DE" sz="1400" dirty="0"/>
          </a:p>
        </p:txBody>
      </p:sp>
      <p:pic>
        <p:nvPicPr>
          <p:cNvPr id="21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632" y="1542420"/>
            <a:ext cx="2820311" cy="2669540"/>
          </a:xfrm>
          <a:prstGeom prst="rect">
            <a:avLst/>
          </a:prstGeom>
        </p:spPr>
      </p:pic>
      <p:pic>
        <p:nvPicPr>
          <p:cNvPr id="22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73822" y="1542420"/>
            <a:ext cx="2823529" cy="2672586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476672" y="5148064"/>
            <a:ext cx="3427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/>
              <a:t>Supplemental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figure</a:t>
            </a:r>
            <a:r>
              <a:rPr lang="de-DE" sz="1400" b="1" dirty="0" smtClean="0"/>
              <a:t> 1. </a:t>
            </a:r>
            <a:r>
              <a:rPr lang="de-DE" sz="1400" dirty="0" err="1" smtClean="0"/>
              <a:t>Gating</a:t>
            </a:r>
            <a:r>
              <a:rPr lang="de-DE" sz="1400" dirty="0" smtClean="0"/>
              <a:t> </a:t>
            </a:r>
            <a:r>
              <a:rPr lang="de-DE" sz="1400" dirty="0" err="1" smtClean="0"/>
              <a:t>strategy</a:t>
            </a:r>
            <a:endParaRPr lang="de-DE" sz="1400" dirty="0" smtClean="0"/>
          </a:p>
        </p:txBody>
      </p:sp>
    </p:spTree>
    <p:extLst>
      <p:ext uri="{BB962C8B-B14F-4D97-AF65-F5344CB8AC3E}">
        <p14:creationId xmlns:p14="http://schemas.microsoft.com/office/powerpoint/2010/main" val="321377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</Words>
  <Application>Microsoft Macintosh PowerPoint</Application>
  <PresentationFormat>Bildschirmpräsentatio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us Brameier</dc:creator>
  <cp:keywords/>
  <cp:lastModifiedBy>Lutz Walter</cp:lastModifiedBy>
  <cp:revision>9</cp:revision>
  <cp:lastPrinted>2012-03-14T16:25:09Z</cp:lastPrinted>
  <dcterms:created xsi:type="dcterms:W3CDTF">2012-03-21T07:17:09Z</dcterms:created>
  <dcterms:modified xsi:type="dcterms:W3CDTF">2012-07-19T12:18:24Z</dcterms:modified>
</cp:coreProperties>
</file>